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6AB11F7-F087-4656-828A-857BDCAFE7B6}" v="1" dt="2023-07-20T09:17:19.48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 showGuides="1">
      <p:cViewPr varScale="1">
        <p:scale>
          <a:sx n="101" d="100"/>
          <a:sy n="101" d="100"/>
        </p:scale>
        <p:origin x="144" y="21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anuta Szirmai" userId="8dfab73839c8df6c" providerId="LiveId" clId="{36AB11F7-F087-4656-828A-857BDCAFE7B6}"/>
    <pc:docChg chg="custSel modSld">
      <pc:chgData name="Danuta Szirmai" userId="8dfab73839c8df6c" providerId="LiveId" clId="{36AB11F7-F087-4656-828A-857BDCAFE7B6}" dt="2023-07-20T09:22:50.355" v="53" actId="478"/>
      <pc:docMkLst>
        <pc:docMk/>
      </pc:docMkLst>
      <pc:sldChg chg="addSp delSp modSp mod">
        <pc:chgData name="Danuta Szirmai" userId="8dfab73839c8df6c" providerId="LiveId" clId="{36AB11F7-F087-4656-828A-857BDCAFE7B6}" dt="2023-07-20T09:22:50.355" v="53" actId="478"/>
        <pc:sldMkLst>
          <pc:docMk/>
          <pc:sldMk cId="4195717919" sldId="256"/>
        </pc:sldMkLst>
        <pc:spChg chg="add del mod">
          <ac:chgData name="Danuta Szirmai" userId="8dfab73839c8df6c" providerId="LiveId" clId="{36AB11F7-F087-4656-828A-857BDCAFE7B6}" dt="2023-07-20T09:22:50.355" v="53" actId="478"/>
          <ac:spMkLst>
            <pc:docMk/>
            <pc:sldMk cId="4195717919" sldId="256"/>
            <ac:spMk id="70" creationId="{A8A5E58F-6106-E4B8-7F8F-5DEA96066B1A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CE5C803C-FACE-0719-66AA-6C9053102A6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Alcím 2">
            <a:extLst>
              <a:ext uri="{FF2B5EF4-FFF2-40B4-BE49-F238E27FC236}">
                <a16:creationId xmlns:a16="http://schemas.microsoft.com/office/drawing/2014/main" id="{2DC2C12C-C586-FAB6-026E-08932C65EBF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u-HU"/>
              <a:t>Kattintson ide az alcím mintájának szerkesztéséhez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AD5D66AA-8813-118D-5873-50060C406C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2E851-AA35-4B60-9580-B1C8C108462A}" type="datetimeFigureOut">
              <a:rPr lang="hu-HU" smtClean="0"/>
              <a:t>2023. 07. 20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96BE8805-B400-A8E0-DF57-AB24EC2BB9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1DDABB7E-5BF4-F144-47EA-5FD2F6C13D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29593F-8206-4724-A1FD-2761F5736B82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5143444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99509161-E582-1367-8BF6-680F671C3E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>
            <a:extLst>
              <a:ext uri="{FF2B5EF4-FFF2-40B4-BE49-F238E27FC236}">
                <a16:creationId xmlns:a16="http://schemas.microsoft.com/office/drawing/2014/main" id="{0D17F189-9284-4A2E-2302-A9F95770E14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F7F8EF1E-9BEF-0A59-DE03-A83AAAFB1E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2E851-AA35-4B60-9580-B1C8C108462A}" type="datetimeFigureOut">
              <a:rPr lang="hu-HU" smtClean="0"/>
              <a:t>2023. 07. 20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9F1DC972-588D-5870-FDA2-BE561ED015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3F9227A5-693F-65A7-EDA0-A7FC0BC91E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29593F-8206-4724-A1FD-2761F5736B82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5995600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>
            <a:extLst>
              <a:ext uri="{FF2B5EF4-FFF2-40B4-BE49-F238E27FC236}">
                <a16:creationId xmlns:a16="http://schemas.microsoft.com/office/drawing/2014/main" id="{A6240B82-A9D2-2C27-2CF4-D5E14E522D3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>
            <a:extLst>
              <a:ext uri="{FF2B5EF4-FFF2-40B4-BE49-F238E27FC236}">
                <a16:creationId xmlns:a16="http://schemas.microsoft.com/office/drawing/2014/main" id="{11FD5A02-57A7-818B-FCB3-746A46A9A2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DA3D9FA6-E953-9A5B-7686-9EA1210C7A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2E851-AA35-4B60-9580-B1C8C108462A}" type="datetimeFigureOut">
              <a:rPr lang="hu-HU" smtClean="0"/>
              <a:t>2023. 07. 20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30E65C11-F57E-8B3C-FDC7-1DC530AC64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96E447F7-6193-9EC7-9466-E1F88AE207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29593F-8206-4724-A1FD-2761F5736B82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113518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B0655DCD-B305-F88B-8526-82327B6C59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1680B95C-0BF5-FF15-A079-1D5346D1823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7557CF71-FBFB-EB27-4385-D249D405F2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2E851-AA35-4B60-9580-B1C8C108462A}" type="datetimeFigureOut">
              <a:rPr lang="hu-HU" smtClean="0"/>
              <a:t>2023. 07. 20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C17E3264-DC08-61C6-E1CC-EC2A47D974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479A6B54-039A-E34A-521A-5DB025B599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29593F-8206-4724-A1FD-2761F5736B82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5525553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FE522040-C81D-7EEB-4562-90FFBA0C4C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59867405-E34F-2561-B532-831AF98218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05694CDE-E304-ED34-C87D-79117C8D10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2E851-AA35-4B60-9580-B1C8C108462A}" type="datetimeFigureOut">
              <a:rPr lang="hu-HU" smtClean="0"/>
              <a:t>2023. 07. 20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3C21F87D-3249-17DD-C6C7-4AD026B134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72ECA1EB-94CB-7120-F3BF-96ECAA758F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29593F-8206-4724-A1FD-2761F5736B82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1590368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F1992ABA-056D-2A0F-2B74-914AADAF74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CD76FFCD-FB1F-B8BA-6C50-FFAE4B94DEB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Tartalom helye 3">
            <a:extLst>
              <a:ext uri="{FF2B5EF4-FFF2-40B4-BE49-F238E27FC236}">
                <a16:creationId xmlns:a16="http://schemas.microsoft.com/office/drawing/2014/main" id="{A810D9AE-F1E6-B1F8-9527-69D73F9F0E6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8855F166-E9E8-8B5C-A216-FB4AE1778A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2E851-AA35-4B60-9580-B1C8C108462A}" type="datetimeFigureOut">
              <a:rPr lang="hu-HU" smtClean="0"/>
              <a:t>2023. 07. 20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F83E795A-E15B-0B8F-2D29-948E0EC997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16056EF9-759C-42D5-26D3-A0CCE511AB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29593F-8206-4724-A1FD-2761F5736B82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7246408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7126CC5A-789A-839A-567E-329C2990FA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BA1F9D19-6720-93CF-AEC7-7EBFBBFBC5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Tartalom helye 3">
            <a:extLst>
              <a:ext uri="{FF2B5EF4-FFF2-40B4-BE49-F238E27FC236}">
                <a16:creationId xmlns:a16="http://schemas.microsoft.com/office/drawing/2014/main" id="{94C3A59F-9145-41D3-4DB1-2B84A5416FF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Szöveg helye 4">
            <a:extLst>
              <a:ext uri="{FF2B5EF4-FFF2-40B4-BE49-F238E27FC236}">
                <a16:creationId xmlns:a16="http://schemas.microsoft.com/office/drawing/2014/main" id="{9D5CCB3F-0EC9-3691-72DD-DA2EEB28BC2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Tartalom helye 5">
            <a:extLst>
              <a:ext uri="{FF2B5EF4-FFF2-40B4-BE49-F238E27FC236}">
                <a16:creationId xmlns:a16="http://schemas.microsoft.com/office/drawing/2014/main" id="{72AE1FDC-C8A5-6572-0078-DCD2A52C2E7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7" name="Dátum helye 6">
            <a:extLst>
              <a:ext uri="{FF2B5EF4-FFF2-40B4-BE49-F238E27FC236}">
                <a16:creationId xmlns:a16="http://schemas.microsoft.com/office/drawing/2014/main" id="{B70088A1-37FE-BF78-F272-F4EBDC2348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2E851-AA35-4B60-9580-B1C8C108462A}" type="datetimeFigureOut">
              <a:rPr lang="hu-HU" smtClean="0"/>
              <a:t>2023. 07. 20.</a:t>
            </a:fld>
            <a:endParaRPr lang="hu-HU"/>
          </a:p>
        </p:txBody>
      </p:sp>
      <p:sp>
        <p:nvSpPr>
          <p:cNvPr id="8" name="Élőláb helye 7">
            <a:extLst>
              <a:ext uri="{FF2B5EF4-FFF2-40B4-BE49-F238E27FC236}">
                <a16:creationId xmlns:a16="http://schemas.microsoft.com/office/drawing/2014/main" id="{9EF6C7B3-70E7-AEC3-91A9-2105C34C55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Dia számának helye 8">
            <a:extLst>
              <a:ext uri="{FF2B5EF4-FFF2-40B4-BE49-F238E27FC236}">
                <a16:creationId xmlns:a16="http://schemas.microsoft.com/office/drawing/2014/main" id="{2A0DE846-881F-33AB-8B9A-D66F1F42E5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29593F-8206-4724-A1FD-2761F5736B82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956148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2AFD2E7E-016B-4A4D-9B0F-BF12DA93F8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Dátum helye 2">
            <a:extLst>
              <a:ext uri="{FF2B5EF4-FFF2-40B4-BE49-F238E27FC236}">
                <a16:creationId xmlns:a16="http://schemas.microsoft.com/office/drawing/2014/main" id="{5B7EF7C9-71EA-0466-D181-55250DF173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2E851-AA35-4B60-9580-B1C8C108462A}" type="datetimeFigureOut">
              <a:rPr lang="hu-HU" smtClean="0"/>
              <a:t>2023. 07. 20.</a:t>
            </a:fld>
            <a:endParaRPr lang="hu-HU"/>
          </a:p>
        </p:txBody>
      </p:sp>
      <p:sp>
        <p:nvSpPr>
          <p:cNvPr id="4" name="Élőláb helye 3">
            <a:extLst>
              <a:ext uri="{FF2B5EF4-FFF2-40B4-BE49-F238E27FC236}">
                <a16:creationId xmlns:a16="http://schemas.microsoft.com/office/drawing/2014/main" id="{1CEF12AA-498F-AA1A-797C-4DC71C2AEB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Dia számának helye 4">
            <a:extLst>
              <a:ext uri="{FF2B5EF4-FFF2-40B4-BE49-F238E27FC236}">
                <a16:creationId xmlns:a16="http://schemas.microsoft.com/office/drawing/2014/main" id="{22D543F1-5837-BA1F-7A67-46281E548F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29593F-8206-4724-A1FD-2761F5736B82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2272935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>
            <a:extLst>
              <a:ext uri="{FF2B5EF4-FFF2-40B4-BE49-F238E27FC236}">
                <a16:creationId xmlns:a16="http://schemas.microsoft.com/office/drawing/2014/main" id="{FF828279-42CF-AFEC-CA2F-1319F947FC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2E851-AA35-4B60-9580-B1C8C108462A}" type="datetimeFigureOut">
              <a:rPr lang="hu-HU" smtClean="0"/>
              <a:t>2023. 07. 20.</a:t>
            </a:fld>
            <a:endParaRPr lang="hu-HU"/>
          </a:p>
        </p:txBody>
      </p:sp>
      <p:sp>
        <p:nvSpPr>
          <p:cNvPr id="3" name="Élőláb helye 2">
            <a:extLst>
              <a:ext uri="{FF2B5EF4-FFF2-40B4-BE49-F238E27FC236}">
                <a16:creationId xmlns:a16="http://schemas.microsoft.com/office/drawing/2014/main" id="{AC21A73A-10E7-020C-5CA7-3D1B82A318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Dia számának helye 3">
            <a:extLst>
              <a:ext uri="{FF2B5EF4-FFF2-40B4-BE49-F238E27FC236}">
                <a16:creationId xmlns:a16="http://schemas.microsoft.com/office/drawing/2014/main" id="{0266C125-8016-784E-F7C1-DB1A1C934D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29593F-8206-4724-A1FD-2761F5736B82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441439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F0C39269-84D4-BBB8-8CDC-26D7841379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49E94217-F566-D6EB-B824-0A190AA1514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Szöveg helye 3">
            <a:extLst>
              <a:ext uri="{FF2B5EF4-FFF2-40B4-BE49-F238E27FC236}">
                <a16:creationId xmlns:a16="http://schemas.microsoft.com/office/drawing/2014/main" id="{2CEF4E72-5C33-1F1B-8AAB-46424F722B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E264D2F7-D648-2865-6685-6C627B7E36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2E851-AA35-4B60-9580-B1C8C108462A}" type="datetimeFigureOut">
              <a:rPr lang="hu-HU" smtClean="0"/>
              <a:t>2023. 07. 20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A5A05A32-C90A-E0C5-8C32-307FEC93F5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BDD631B5-4048-052A-4906-87E55D609A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29593F-8206-4724-A1FD-2761F5736B82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4882050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7AB0EEE7-D264-280B-33E0-13650D89C2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Kép helye 2">
            <a:extLst>
              <a:ext uri="{FF2B5EF4-FFF2-40B4-BE49-F238E27FC236}">
                <a16:creationId xmlns:a16="http://schemas.microsoft.com/office/drawing/2014/main" id="{6229F71E-18F2-F3F8-D26F-B980BCDFFF6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u-HU"/>
          </a:p>
        </p:txBody>
      </p:sp>
      <p:sp>
        <p:nvSpPr>
          <p:cNvPr id="4" name="Szöveg helye 3">
            <a:extLst>
              <a:ext uri="{FF2B5EF4-FFF2-40B4-BE49-F238E27FC236}">
                <a16:creationId xmlns:a16="http://schemas.microsoft.com/office/drawing/2014/main" id="{15F55826-7AD4-E6D5-DCBB-87260A9E177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310B3060-36D5-45AF-28E8-61B6969C5C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2E851-AA35-4B60-9580-B1C8C108462A}" type="datetimeFigureOut">
              <a:rPr lang="hu-HU" smtClean="0"/>
              <a:t>2023. 07. 20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0209B400-C684-A54A-E3D4-F9F18893C4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43A15604-698F-C3B7-C623-9ED3255B44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29593F-8206-4724-A1FD-2761F5736B82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2160769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>
            <a:extLst>
              <a:ext uri="{FF2B5EF4-FFF2-40B4-BE49-F238E27FC236}">
                <a16:creationId xmlns:a16="http://schemas.microsoft.com/office/drawing/2014/main" id="{D5B41354-3594-E7B5-E19C-E4551AB661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F6C16C84-AF94-75C9-C6AD-5C8DDFF565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A9A2EC0F-A329-5EBA-9766-B0BF9BC55A6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E2E851-AA35-4B60-9580-B1C8C108462A}" type="datetimeFigureOut">
              <a:rPr lang="hu-HU" smtClean="0"/>
              <a:t>2023. 07. 20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100BDE43-8509-46A2-69BF-57A4C5BAB16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A2DA4ACD-BE66-7472-868D-D266A035500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29593F-8206-4724-A1FD-2761F5736B82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1276196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u-H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4">
            <a:extLst>
              <a:ext uri="{FF2B5EF4-FFF2-40B4-BE49-F238E27FC236}">
                <a16:creationId xmlns:a16="http://schemas.microsoft.com/office/drawing/2014/main" id="{CED73F00-E0C5-2F7A-7BBF-39CF028D4F76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203598" y="2286000"/>
            <a:ext cx="11801736" cy="2382837"/>
            <a:chOff x="1607" y="1778"/>
            <a:chExt cx="4408" cy="890"/>
          </a:xfrm>
        </p:grpSpPr>
        <p:sp>
          <p:nvSpPr>
            <p:cNvPr id="5" name="Rectangle 5">
              <a:extLst>
                <a:ext uri="{FF2B5EF4-FFF2-40B4-BE49-F238E27FC236}">
                  <a16:creationId xmlns:a16="http://schemas.microsoft.com/office/drawing/2014/main" id="{1C4BA441-8E72-9582-1446-3363EF9761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07" y="1778"/>
              <a:ext cx="525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Author and year</a:t>
              </a:r>
              <a:endParaRPr kumimoji="0" lang="hu-HU" altLang="hu-HU" sz="3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" name="Rectangle 6">
              <a:extLst>
                <a:ext uri="{FF2B5EF4-FFF2-40B4-BE49-F238E27FC236}">
                  <a16:creationId xmlns:a16="http://schemas.microsoft.com/office/drawing/2014/main" id="{D5F5A179-F3CD-3027-93ED-E04294B8D4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07" y="2352"/>
              <a:ext cx="899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Random effects model (HK)</a:t>
              </a:r>
              <a:endParaRPr kumimoji="0" lang="hu-HU" altLang="hu-HU" sz="3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" name="Rectangle 7">
              <a:extLst>
                <a:ext uri="{FF2B5EF4-FFF2-40B4-BE49-F238E27FC236}">
                  <a16:creationId xmlns:a16="http://schemas.microsoft.com/office/drawing/2014/main" id="{F576B6AB-0681-E245-2BB3-1F7C3A990F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07" y="2456"/>
              <a:ext cx="398" cy="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Heterogeneity: </a:t>
              </a:r>
              <a:endParaRPr kumimoji="0" lang="hu-HU" altLang="hu-HU" sz="3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" name="Rectangle 8">
              <a:extLst>
                <a:ext uri="{FF2B5EF4-FFF2-40B4-BE49-F238E27FC236}">
                  <a16:creationId xmlns:a16="http://schemas.microsoft.com/office/drawing/2014/main" id="{C950705C-0E46-70D0-238F-022F36226D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47" y="2456"/>
              <a:ext cx="17" cy="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2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I</a:t>
              </a:r>
              <a:endParaRPr kumimoji="0" lang="hu-HU" altLang="hu-HU" sz="3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" name="Rectangle 9">
              <a:extLst>
                <a:ext uri="{FF2B5EF4-FFF2-40B4-BE49-F238E27FC236}">
                  <a16:creationId xmlns:a16="http://schemas.microsoft.com/office/drawing/2014/main" id="{B1729B65-9877-07BA-89E1-9E1857949D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70" y="2442"/>
              <a:ext cx="29" cy="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2</a:t>
              </a:r>
              <a:endParaRPr kumimoji="0" lang="hu-HU" altLang="hu-HU" sz="3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" name="Rectangle 10">
              <a:extLst>
                <a:ext uri="{FF2B5EF4-FFF2-40B4-BE49-F238E27FC236}">
                  <a16:creationId xmlns:a16="http://schemas.microsoft.com/office/drawing/2014/main" id="{BD5FD0BD-6D1C-BCB1-A640-54499A9F46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95" y="2456"/>
              <a:ext cx="502" cy="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 = 74% [12%; 92%]</a:t>
              </a:r>
              <a:endParaRPr kumimoji="0" lang="hu-HU" altLang="hu-HU" sz="3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" name="Rectangle 11">
              <a:extLst>
                <a:ext uri="{FF2B5EF4-FFF2-40B4-BE49-F238E27FC236}">
                  <a16:creationId xmlns:a16="http://schemas.microsoft.com/office/drawing/2014/main" id="{C20F5B23-C2D4-DA91-938A-392D9C65FC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49" y="2456"/>
              <a:ext cx="17" cy="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 </a:t>
              </a:r>
              <a:endParaRPr kumimoji="0" lang="hu-HU" altLang="hu-HU" sz="3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" name="Rectangle 16">
              <a:extLst>
                <a:ext uri="{FF2B5EF4-FFF2-40B4-BE49-F238E27FC236}">
                  <a16:creationId xmlns:a16="http://schemas.microsoft.com/office/drawing/2014/main" id="{6C344BE8-7237-2421-F26E-B3BDD3863F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44" y="2456"/>
              <a:ext cx="0" cy="2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hu-HU" altLang="hu-HU" sz="3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" name="Rectangle 17">
              <a:extLst>
                <a:ext uri="{FF2B5EF4-FFF2-40B4-BE49-F238E27FC236}">
                  <a16:creationId xmlns:a16="http://schemas.microsoft.com/office/drawing/2014/main" id="{02115892-1FDB-6D57-3876-D7A92BDFD5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87" y="2456"/>
              <a:ext cx="0" cy="2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hu-HU" altLang="hu-HU" sz="3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" name="Rectangle 18">
              <a:extLst>
                <a:ext uri="{FF2B5EF4-FFF2-40B4-BE49-F238E27FC236}">
                  <a16:creationId xmlns:a16="http://schemas.microsoft.com/office/drawing/2014/main" id="{3BE53EE2-0A9C-175E-D4CC-EDB92ED534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07" y="1971"/>
              <a:ext cx="457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Bai et al., 2019</a:t>
              </a:r>
              <a:endParaRPr kumimoji="0" lang="hu-HU" altLang="hu-HU" sz="3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" name="Rectangle 19">
              <a:extLst>
                <a:ext uri="{FF2B5EF4-FFF2-40B4-BE49-F238E27FC236}">
                  <a16:creationId xmlns:a16="http://schemas.microsoft.com/office/drawing/2014/main" id="{3D3E6091-D204-9FA9-2613-827F8558709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07" y="2067"/>
              <a:ext cx="556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Stefan et al., 2018</a:t>
              </a:r>
              <a:endParaRPr kumimoji="0" lang="hu-HU" altLang="hu-HU" sz="3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" name="Rectangle 20">
              <a:extLst>
                <a:ext uri="{FF2B5EF4-FFF2-40B4-BE49-F238E27FC236}">
                  <a16:creationId xmlns:a16="http://schemas.microsoft.com/office/drawing/2014/main" id="{F61BC855-8BB4-E6E8-3C34-CDD8B7D8B3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07" y="2163"/>
              <a:ext cx="598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Chennu et al., 2017</a:t>
              </a:r>
              <a:endParaRPr kumimoji="0" lang="hu-HU" altLang="hu-HU" sz="3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" name="Rectangle 21">
              <a:extLst>
                <a:ext uri="{FF2B5EF4-FFF2-40B4-BE49-F238E27FC236}">
                  <a16:creationId xmlns:a16="http://schemas.microsoft.com/office/drawing/2014/main" id="{8F75AA38-E5E5-27D6-708A-4E5A3E135F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72" y="1778"/>
              <a:ext cx="50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N</a:t>
              </a:r>
              <a:endParaRPr kumimoji="0" lang="hu-HU" altLang="hu-HU" sz="3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" name="Rectangle 22">
              <a:extLst>
                <a:ext uri="{FF2B5EF4-FFF2-40B4-BE49-F238E27FC236}">
                  <a16:creationId xmlns:a16="http://schemas.microsoft.com/office/drawing/2014/main" id="{B6D73FA6-DA2D-C094-E9FD-73928FB7D9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60" y="1971"/>
              <a:ext cx="76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51</a:t>
              </a:r>
              <a:endParaRPr kumimoji="0" lang="hu-HU" altLang="hu-HU" sz="3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" name="Rectangle 23">
              <a:extLst>
                <a:ext uri="{FF2B5EF4-FFF2-40B4-BE49-F238E27FC236}">
                  <a16:creationId xmlns:a16="http://schemas.microsoft.com/office/drawing/2014/main" id="{FAD783D3-A4DC-A149-6AFE-A383F8A658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60" y="2067"/>
              <a:ext cx="76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39</a:t>
              </a:r>
              <a:endParaRPr kumimoji="0" lang="hu-HU" altLang="hu-HU" sz="3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" name="Rectangle 24">
              <a:extLst>
                <a:ext uri="{FF2B5EF4-FFF2-40B4-BE49-F238E27FC236}">
                  <a16:creationId xmlns:a16="http://schemas.microsoft.com/office/drawing/2014/main" id="{8848DB46-905F-927B-A7D8-8E684C4F26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60" y="2163"/>
              <a:ext cx="76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61</a:t>
              </a:r>
              <a:endParaRPr kumimoji="0" lang="hu-HU" altLang="hu-HU" sz="3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" name="Rectangle 25">
              <a:extLst>
                <a:ext uri="{FF2B5EF4-FFF2-40B4-BE49-F238E27FC236}">
                  <a16:creationId xmlns:a16="http://schemas.microsoft.com/office/drawing/2014/main" id="{B7EAF8B3-1AE5-0C83-2433-2B4F00B641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70" y="1778"/>
              <a:ext cx="328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400" b="1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recovered</a:t>
              </a:r>
              <a:endParaRPr kumimoji="0" lang="hu-HU" altLang="hu-HU" sz="3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" name="Rectangle 26">
              <a:extLst>
                <a:ext uri="{FF2B5EF4-FFF2-40B4-BE49-F238E27FC236}">
                  <a16:creationId xmlns:a16="http://schemas.microsoft.com/office/drawing/2014/main" id="{C914FD80-EF47-5803-6A61-E932547C2F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23" y="1971"/>
              <a:ext cx="38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6</a:t>
              </a:r>
              <a:endParaRPr kumimoji="0" lang="hu-HU" altLang="hu-HU" sz="3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" name="Rectangle 27">
              <a:extLst>
                <a:ext uri="{FF2B5EF4-FFF2-40B4-BE49-F238E27FC236}">
                  <a16:creationId xmlns:a16="http://schemas.microsoft.com/office/drawing/2014/main" id="{3E8662B3-DE2C-52A7-E37C-446FD33E31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3" y="2067"/>
              <a:ext cx="76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10</a:t>
              </a:r>
              <a:endParaRPr kumimoji="0" lang="hu-HU" altLang="hu-HU" sz="3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" name="Rectangle 28">
              <a:extLst>
                <a:ext uri="{FF2B5EF4-FFF2-40B4-BE49-F238E27FC236}">
                  <a16:creationId xmlns:a16="http://schemas.microsoft.com/office/drawing/2014/main" id="{E4C591A9-EE75-0870-3037-F935B1A312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3" y="2163"/>
              <a:ext cx="76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30</a:t>
              </a:r>
              <a:endParaRPr kumimoji="0" lang="hu-HU" altLang="hu-HU" sz="3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" name="Rectangle 29">
              <a:extLst>
                <a:ext uri="{FF2B5EF4-FFF2-40B4-BE49-F238E27FC236}">
                  <a16:creationId xmlns:a16="http://schemas.microsoft.com/office/drawing/2014/main" id="{B1646DA7-B7A2-3853-6280-26647680B9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43" y="1778"/>
              <a:ext cx="453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not recovered</a:t>
              </a:r>
              <a:endParaRPr kumimoji="0" lang="hu-HU" altLang="hu-HU" sz="3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" name="Rectangle 30">
              <a:extLst>
                <a:ext uri="{FF2B5EF4-FFF2-40B4-BE49-F238E27FC236}">
                  <a16:creationId xmlns:a16="http://schemas.microsoft.com/office/drawing/2014/main" id="{F8FA279E-63F0-45F2-BA81-99314655EB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42" y="1971"/>
              <a:ext cx="76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45</a:t>
              </a:r>
              <a:endParaRPr kumimoji="0" lang="hu-HU" altLang="hu-HU" sz="3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Rectangle 31">
              <a:extLst>
                <a:ext uri="{FF2B5EF4-FFF2-40B4-BE49-F238E27FC236}">
                  <a16:creationId xmlns:a16="http://schemas.microsoft.com/office/drawing/2014/main" id="{47E26829-D5C7-6E55-B0F2-627A77F720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42" y="2067"/>
              <a:ext cx="76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29</a:t>
              </a:r>
              <a:endParaRPr kumimoji="0" lang="hu-HU" altLang="hu-HU" sz="3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" name="Rectangle 32">
              <a:extLst>
                <a:ext uri="{FF2B5EF4-FFF2-40B4-BE49-F238E27FC236}">
                  <a16:creationId xmlns:a16="http://schemas.microsoft.com/office/drawing/2014/main" id="{BA7C1F6B-0BF6-32EC-0DE5-EB791D8588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42" y="2163"/>
              <a:ext cx="76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31</a:t>
              </a:r>
              <a:endParaRPr kumimoji="0" lang="hu-HU" altLang="hu-HU" sz="3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" name="Line 33">
              <a:extLst>
                <a:ext uri="{FF2B5EF4-FFF2-40B4-BE49-F238E27FC236}">
                  <a16:creationId xmlns:a16="http://schemas.microsoft.com/office/drawing/2014/main" id="{01BEC772-89FB-64E5-1CC4-62E754DE5A2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439" y="1963"/>
              <a:ext cx="0" cy="479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3600"/>
            </a:p>
          </p:txBody>
        </p:sp>
        <p:sp>
          <p:nvSpPr>
            <p:cNvPr id="30" name="Line 34">
              <a:extLst>
                <a:ext uri="{FF2B5EF4-FFF2-40B4-BE49-F238E27FC236}">
                  <a16:creationId xmlns:a16="http://schemas.microsoft.com/office/drawing/2014/main" id="{AF5E100B-B123-AD13-6B24-B0FDC5D41F3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28" y="1963"/>
              <a:ext cx="0" cy="431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ysDot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3600"/>
            </a:p>
          </p:txBody>
        </p:sp>
        <p:sp>
          <p:nvSpPr>
            <p:cNvPr id="31" name="Line 35">
              <a:extLst>
                <a:ext uri="{FF2B5EF4-FFF2-40B4-BE49-F238E27FC236}">
                  <a16:creationId xmlns:a16="http://schemas.microsoft.com/office/drawing/2014/main" id="{FA2BC11A-C5A2-D775-E46C-C6BAF38B4C0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74" y="2442"/>
              <a:ext cx="1131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3600"/>
            </a:p>
          </p:txBody>
        </p:sp>
        <p:sp>
          <p:nvSpPr>
            <p:cNvPr id="32" name="Line 36">
              <a:extLst>
                <a:ext uri="{FF2B5EF4-FFF2-40B4-BE49-F238E27FC236}">
                  <a16:creationId xmlns:a16="http://schemas.microsoft.com/office/drawing/2014/main" id="{44F7EC66-27F9-9457-BDF6-EF35D2DDDDB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74" y="2442"/>
              <a:ext cx="0" cy="44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3600"/>
            </a:p>
          </p:txBody>
        </p:sp>
        <p:sp>
          <p:nvSpPr>
            <p:cNvPr id="33" name="Line 37">
              <a:extLst>
                <a:ext uri="{FF2B5EF4-FFF2-40B4-BE49-F238E27FC236}">
                  <a16:creationId xmlns:a16="http://schemas.microsoft.com/office/drawing/2014/main" id="{A2ABAFC6-DC7E-8C3A-DC7C-DA3710258A8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00" y="2442"/>
              <a:ext cx="0" cy="44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3600"/>
            </a:p>
          </p:txBody>
        </p:sp>
        <p:sp>
          <p:nvSpPr>
            <p:cNvPr id="34" name="Line 38">
              <a:extLst>
                <a:ext uri="{FF2B5EF4-FFF2-40B4-BE49-F238E27FC236}">
                  <a16:creationId xmlns:a16="http://schemas.microsoft.com/office/drawing/2014/main" id="{B930B164-8211-A550-CC70-9834D28E102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25" y="2442"/>
              <a:ext cx="0" cy="44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3600"/>
            </a:p>
          </p:txBody>
        </p:sp>
        <p:sp>
          <p:nvSpPr>
            <p:cNvPr id="35" name="Line 39">
              <a:extLst>
                <a:ext uri="{FF2B5EF4-FFF2-40B4-BE49-F238E27FC236}">
                  <a16:creationId xmlns:a16="http://schemas.microsoft.com/office/drawing/2014/main" id="{E8DA8584-797F-5A19-C20B-EEDFF232F37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52" y="2442"/>
              <a:ext cx="0" cy="44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3600"/>
            </a:p>
          </p:txBody>
        </p:sp>
        <p:sp>
          <p:nvSpPr>
            <p:cNvPr id="36" name="Line 40">
              <a:extLst>
                <a:ext uri="{FF2B5EF4-FFF2-40B4-BE49-F238E27FC236}">
                  <a16:creationId xmlns:a16="http://schemas.microsoft.com/office/drawing/2014/main" id="{5C9F1563-3D8D-E95A-9390-CD5E6A7D7E7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778" y="2442"/>
              <a:ext cx="0" cy="44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3600"/>
            </a:p>
          </p:txBody>
        </p:sp>
        <p:sp>
          <p:nvSpPr>
            <p:cNvPr id="37" name="Line 41">
              <a:extLst>
                <a:ext uri="{FF2B5EF4-FFF2-40B4-BE49-F238E27FC236}">
                  <a16:creationId xmlns:a16="http://schemas.microsoft.com/office/drawing/2014/main" id="{8B5EA35C-928C-8647-CDD7-13DCE2F73A8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05" y="2442"/>
              <a:ext cx="0" cy="44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3600"/>
            </a:p>
          </p:txBody>
        </p:sp>
        <p:sp>
          <p:nvSpPr>
            <p:cNvPr id="38" name="Rectangle 42">
              <a:extLst>
                <a:ext uri="{FF2B5EF4-FFF2-40B4-BE49-F238E27FC236}">
                  <a16:creationId xmlns:a16="http://schemas.microsoft.com/office/drawing/2014/main" id="{CFAF38C6-4CB2-8B14-AAD4-2940DCC5EE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38" y="2533"/>
              <a:ext cx="38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0</a:t>
              </a:r>
              <a:endParaRPr kumimoji="0" lang="hu-HU" altLang="hu-HU" sz="3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" name="Rectangle 43">
              <a:extLst>
                <a:ext uri="{FF2B5EF4-FFF2-40B4-BE49-F238E27FC236}">
                  <a16:creationId xmlns:a16="http://schemas.microsoft.com/office/drawing/2014/main" id="{EED65D8B-97D5-2778-81E0-7F33EDAD42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33" y="2533"/>
              <a:ext cx="95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0.2</a:t>
              </a:r>
              <a:endParaRPr kumimoji="0" lang="hu-HU" altLang="hu-HU" sz="3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" name="Rectangle 44">
              <a:extLst>
                <a:ext uri="{FF2B5EF4-FFF2-40B4-BE49-F238E27FC236}">
                  <a16:creationId xmlns:a16="http://schemas.microsoft.com/office/drawing/2014/main" id="{474DEA04-5264-7545-5C23-89A83435A6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59" y="2533"/>
              <a:ext cx="95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0.4</a:t>
              </a:r>
              <a:endParaRPr kumimoji="0" lang="hu-HU" altLang="hu-HU" sz="3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" name="Rectangle 45">
              <a:extLst>
                <a:ext uri="{FF2B5EF4-FFF2-40B4-BE49-F238E27FC236}">
                  <a16:creationId xmlns:a16="http://schemas.microsoft.com/office/drawing/2014/main" id="{9919C111-D4D1-2AD8-919F-FEB8F3460B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86" y="2533"/>
              <a:ext cx="95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0.6</a:t>
              </a:r>
              <a:endParaRPr kumimoji="0" lang="hu-HU" altLang="hu-HU" sz="3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" name="Rectangle 46">
              <a:extLst>
                <a:ext uri="{FF2B5EF4-FFF2-40B4-BE49-F238E27FC236}">
                  <a16:creationId xmlns:a16="http://schemas.microsoft.com/office/drawing/2014/main" id="{28E3261D-07B0-17EB-5C5D-3414D8DA39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11" y="2533"/>
              <a:ext cx="95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0.8</a:t>
              </a:r>
              <a:endParaRPr kumimoji="0" lang="hu-HU" altLang="hu-HU" sz="3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" name="Rectangle 47">
              <a:extLst>
                <a:ext uri="{FF2B5EF4-FFF2-40B4-BE49-F238E27FC236}">
                  <a16:creationId xmlns:a16="http://schemas.microsoft.com/office/drawing/2014/main" id="{2866BB77-418C-2D82-C8AD-BAF388A7F1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67" y="2533"/>
              <a:ext cx="38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1</a:t>
              </a:r>
              <a:endParaRPr kumimoji="0" lang="hu-HU" altLang="hu-HU" sz="3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" name="Rectangle 48">
              <a:extLst>
                <a:ext uri="{FF2B5EF4-FFF2-40B4-BE49-F238E27FC236}">
                  <a16:creationId xmlns:a16="http://schemas.microsoft.com/office/drawing/2014/main" id="{76CA61BC-105E-7D3D-6DE1-AC034BB7FD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45" y="1778"/>
              <a:ext cx="149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AUC</a:t>
              </a:r>
              <a:endParaRPr kumimoji="0" lang="hu-HU" altLang="hu-HU" sz="3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" name="Freeform 49">
              <a:extLst>
                <a:ext uri="{FF2B5EF4-FFF2-40B4-BE49-F238E27FC236}">
                  <a16:creationId xmlns:a16="http://schemas.microsoft.com/office/drawing/2014/main" id="{99449095-2F75-F8CA-076B-AC0A9D0166C0}"/>
                </a:ext>
              </a:extLst>
            </p:cNvPr>
            <p:cNvSpPr>
              <a:spLocks/>
            </p:cNvSpPr>
            <p:nvPr/>
          </p:nvSpPr>
          <p:spPr bwMode="auto">
            <a:xfrm>
              <a:off x="3995" y="2371"/>
              <a:ext cx="1010" cy="45"/>
            </a:xfrm>
            <a:custGeom>
              <a:avLst/>
              <a:gdLst>
                <a:gd name="T0" fmla="*/ 0 w 1010"/>
                <a:gd name="T1" fmla="*/ 23 h 45"/>
                <a:gd name="T2" fmla="*/ 533 w 1010"/>
                <a:gd name="T3" fmla="*/ 0 h 45"/>
                <a:gd name="T4" fmla="*/ 1010 w 1010"/>
                <a:gd name="T5" fmla="*/ 23 h 45"/>
                <a:gd name="T6" fmla="*/ 533 w 1010"/>
                <a:gd name="T7" fmla="*/ 45 h 45"/>
                <a:gd name="T8" fmla="*/ 0 w 1010"/>
                <a:gd name="T9" fmla="*/ 23 h 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010" h="45">
                  <a:moveTo>
                    <a:pt x="0" y="23"/>
                  </a:moveTo>
                  <a:lnTo>
                    <a:pt x="533" y="0"/>
                  </a:lnTo>
                  <a:lnTo>
                    <a:pt x="1010" y="23"/>
                  </a:lnTo>
                  <a:lnTo>
                    <a:pt x="533" y="45"/>
                  </a:lnTo>
                  <a:lnTo>
                    <a:pt x="0" y="23"/>
                  </a:lnTo>
                  <a:close/>
                </a:path>
              </a:pathLst>
            </a:custGeom>
            <a:solidFill>
              <a:srgbClr val="0000FF"/>
            </a:solidFill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3600"/>
            </a:p>
          </p:txBody>
        </p:sp>
        <p:sp>
          <p:nvSpPr>
            <p:cNvPr id="46" name="Rectangle 50">
              <a:extLst>
                <a:ext uri="{FF2B5EF4-FFF2-40B4-BE49-F238E27FC236}">
                  <a16:creationId xmlns:a16="http://schemas.microsoft.com/office/drawing/2014/main" id="{726F9618-3327-B22A-EA26-9B9294551C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23" y="1977"/>
              <a:ext cx="69" cy="67"/>
            </a:xfrm>
            <a:prstGeom prst="rect">
              <a:avLst/>
            </a:prstGeom>
            <a:solidFill>
              <a:srgbClr val="FF0000"/>
            </a:solidFill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3600"/>
            </a:p>
          </p:txBody>
        </p:sp>
        <p:sp>
          <p:nvSpPr>
            <p:cNvPr id="47" name="Line 51">
              <a:extLst>
                <a:ext uri="{FF2B5EF4-FFF2-40B4-BE49-F238E27FC236}">
                  <a16:creationId xmlns:a16="http://schemas.microsoft.com/office/drawing/2014/main" id="{10BF2BF7-3471-639A-2F0D-6AC7A169555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57" y="2001"/>
              <a:ext cx="0" cy="19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3600"/>
            </a:p>
          </p:txBody>
        </p:sp>
        <p:sp>
          <p:nvSpPr>
            <p:cNvPr id="48" name="Line 52">
              <a:extLst>
                <a:ext uri="{FF2B5EF4-FFF2-40B4-BE49-F238E27FC236}">
                  <a16:creationId xmlns:a16="http://schemas.microsoft.com/office/drawing/2014/main" id="{E845CBE5-6E2C-6F19-2FB3-33A60CDD6B6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92" y="2011"/>
              <a:ext cx="530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3600"/>
            </a:p>
          </p:txBody>
        </p:sp>
        <p:sp>
          <p:nvSpPr>
            <p:cNvPr id="49" name="Rectangle 53">
              <a:extLst>
                <a:ext uri="{FF2B5EF4-FFF2-40B4-BE49-F238E27FC236}">
                  <a16:creationId xmlns:a16="http://schemas.microsoft.com/office/drawing/2014/main" id="{56FAE39C-76AE-C291-76D1-23D7126262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33" y="2068"/>
              <a:ext cx="76" cy="77"/>
            </a:xfrm>
            <a:prstGeom prst="rect">
              <a:avLst/>
            </a:prstGeom>
            <a:solidFill>
              <a:srgbClr val="FF0000"/>
            </a:solidFill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3600"/>
            </a:p>
          </p:txBody>
        </p:sp>
        <p:sp>
          <p:nvSpPr>
            <p:cNvPr id="50" name="Line 54">
              <a:extLst>
                <a:ext uri="{FF2B5EF4-FFF2-40B4-BE49-F238E27FC236}">
                  <a16:creationId xmlns:a16="http://schemas.microsoft.com/office/drawing/2014/main" id="{6220293C-6FD8-AB1D-7B03-F14EC74DD18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71" y="2097"/>
              <a:ext cx="0" cy="19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3600"/>
            </a:p>
          </p:txBody>
        </p:sp>
        <p:sp>
          <p:nvSpPr>
            <p:cNvPr id="51" name="Line 55">
              <a:extLst>
                <a:ext uri="{FF2B5EF4-FFF2-40B4-BE49-F238E27FC236}">
                  <a16:creationId xmlns:a16="http://schemas.microsoft.com/office/drawing/2014/main" id="{148D788E-2ED3-8E7A-231A-30F6B32EF3E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13" y="2106"/>
              <a:ext cx="316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3600"/>
            </a:p>
          </p:txBody>
        </p:sp>
        <p:sp>
          <p:nvSpPr>
            <p:cNvPr id="52" name="Rectangle 56">
              <a:extLst>
                <a:ext uri="{FF2B5EF4-FFF2-40B4-BE49-F238E27FC236}">
                  <a16:creationId xmlns:a16="http://schemas.microsoft.com/office/drawing/2014/main" id="{967241B7-B8A3-E3B0-8E04-DD5C66DB1C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52" y="2164"/>
              <a:ext cx="77" cy="77"/>
            </a:xfrm>
            <a:prstGeom prst="rect">
              <a:avLst/>
            </a:prstGeom>
            <a:solidFill>
              <a:srgbClr val="FF0000"/>
            </a:solidFill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3600"/>
            </a:p>
          </p:txBody>
        </p:sp>
        <p:sp>
          <p:nvSpPr>
            <p:cNvPr id="53" name="Line 57">
              <a:extLst>
                <a:ext uri="{FF2B5EF4-FFF2-40B4-BE49-F238E27FC236}">
                  <a16:creationId xmlns:a16="http://schemas.microsoft.com/office/drawing/2014/main" id="{8DDB2901-3534-9D42-7582-9DFAB4982E9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91" y="2193"/>
              <a:ext cx="0" cy="19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3600"/>
            </a:p>
          </p:txBody>
        </p:sp>
        <p:sp>
          <p:nvSpPr>
            <p:cNvPr id="54" name="Line 58">
              <a:extLst>
                <a:ext uri="{FF2B5EF4-FFF2-40B4-BE49-F238E27FC236}">
                  <a16:creationId xmlns:a16="http://schemas.microsoft.com/office/drawing/2014/main" id="{20E9D76C-43D3-B364-714C-9D248FBEE78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34" y="2202"/>
              <a:ext cx="315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u-HU" sz="3600"/>
            </a:p>
          </p:txBody>
        </p:sp>
        <p:sp>
          <p:nvSpPr>
            <p:cNvPr id="55" name="Rectangle 59">
              <a:extLst>
                <a:ext uri="{FF2B5EF4-FFF2-40B4-BE49-F238E27FC236}">
                  <a16:creationId xmlns:a16="http://schemas.microsoft.com/office/drawing/2014/main" id="{D78D36BE-712E-3487-5ECE-B4BD4EFE31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50" y="1778"/>
              <a:ext cx="149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AUC</a:t>
              </a:r>
              <a:endParaRPr kumimoji="0" lang="hu-HU" altLang="hu-HU" sz="3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6" name="Rectangle 60">
              <a:extLst>
                <a:ext uri="{FF2B5EF4-FFF2-40B4-BE49-F238E27FC236}">
                  <a16:creationId xmlns:a16="http://schemas.microsoft.com/office/drawing/2014/main" id="{450E5E0B-6E5E-2DF1-C6B8-379CF0B435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39" y="2352"/>
              <a:ext cx="133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0.58</a:t>
              </a:r>
              <a:endParaRPr kumimoji="0" lang="hu-HU" altLang="hu-HU" sz="3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7" name="Rectangle 61">
              <a:extLst>
                <a:ext uri="{FF2B5EF4-FFF2-40B4-BE49-F238E27FC236}">
                  <a16:creationId xmlns:a16="http://schemas.microsoft.com/office/drawing/2014/main" id="{D2202676-99DA-8A36-816C-7DDBE7C1A3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42" y="1971"/>
              <a:ext cx="133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0.34</a:t>
              </a:r>
              <a:endParaRPr kumimoji="0" lang="hu-HU" altLang="hu-HU" sz="3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8" name="Rectangle 62">
              <a:extLst>
                <a:ext uri="{FF2B5EF4-FFF2-40B4-BE49-F238E27FC236}">
                  <a16:creationId xmlns:a16="http://schemas.microsoft.com/office/drawing/2014/main" id="{488B212D-BAAB-66D3-CA91-164C481568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42" y="2067"/>
              <a:ext cx="133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0.62</a:t>
              </a:r>
              <a:endParaRPr kumimoji="0" lang="hu-HU" altLang="hu-HU" sz="3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" name="Rectangle 63">
              <a:extLst>
                <a:ext uri="{FF2B5EF4-FFF2-40B4-BE49-F238E27FC236}">
                  <a16:creationId xmlns:a16="http://schemas.microsoft.com/office/drawing/2014/main" id="{7ECED002-4049-6B66-B9A2-0F49E2FA06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42" y="2163"/>
              <a:ext cx="133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0.72</a:t>
              </a:r>
              <a:endParaRPr kumimoji="0" lang="hu-HU" altLang="hu-HU" sz="3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0" name="Rectangle 64">
              <a:extLst>
                <a:ext uri="{FF2B5EF4-FFF2-40B4-BE49-F238E27FC236}">
                  <a16:creationId xmlns:a16="http://schemas.microsoft.com/office/drawing/2014/main" id="{00DEA008-BC03-4721-9EDD-EE0C2C8648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07" y="1778"/>
              <a:ext cx="229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95%-CI</a:t>
              </a:r>
              <a:endParaRPr kumimoji="0" lang="hu-HU" altLang="hu-HU" sz="3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1" name="Rectangle 65">
              <a:extLst>
                <a:ext uri="{FF2B5EF4-FFF2-40B4-BE49-F238E27FC236}">
                  <a16:creationId xmlns:a16="http://schemas.microsoft.com/office/drawing/2014/main" id="{93AFA0D7-2BA5-1CF8-F28A-A327D8A67D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74" y="2352"/>
              <a:ext cx="350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[0.11; 1.00]</a:t>
              </a:r>
              <a:endParaRPr kumimoji="0" lang="hu-HU" altLang="hu-HU" sz="3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2" name="Rectangle 66">
              <a:extLst>
                <a:ext uri="{FF2B5EF4-FFF2-40B4-BE49-F238E27FC236}">
                  <a16:creationId xmlns:a16="http://schemas.microsoft.com/office/drawing/2014/main" id="{F415F142-C889-1D70-A1E8-E90FA55191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89" y="1971"/>
              <a:ext cx="337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[0.11; 0.57]</a:t>
              </a:r>
              <a:endParaRPr kumimoji="0" lang="hu-HU" altLang="hu-HU" sz="3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3" name="Rectangle 67">
              <a:extLst>
                <a:ext uri="{FF2B5EF4-FFF2-40B4-BE49-F238E27FC236}">
                  <a16:creationId xmlns:a16="http://schemas.microsoft.com/office/drawing/2014/main" id="{7CA6A7FF-B786-7A08-6730-C320C4DEFA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89" y="2067"/>
              <a:ext cx="343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[0.48; 0.76]</a:t>
              </a:r>
              <a:endParaRPr kumimoji="0" lang="hu-HU" altLang="hu-HU" sz="3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4" name="Rectangle 68">
              <a:extLst>
                <a:ext uri="{FF2B5EF4-FFF2-40B4-BE49-F238E27FC236}">
                  <a16:creationId xmlns:a16="http://schemas.microsoft.com/office/drawing/2014/main" id="{D8F41053-7897-E41E-FC31-3BE6007FA1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89" y="2163"/>
              <a:ext cx="343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[0.58; 0.86]</a:t>
              </a:r>
              <a:endParaRPr kumimoji="0" lang="hu-HU" altLang="hu-HU" sz="3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5" name="Rectangle 69">
              <a:extLst>
                <a:ext uri="{FF2B5EF4-FFF2-40B4-BE49-F238E27FC236}">
                  <a16:creationId xmlns:a16="http://schemas.microsoft.com/office/drawing/2014/main" id="{16B24F85-03E9-04A7-8A81-3E765D008B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80" y="1778"/>
              <a:ext cx="227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Weight</a:t>
              </a:r>
              <a:endParaRPr kumimoji="0" lang="hu-HU" altLang="hu-HU" sz="3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" name="Rectangle 70">
              <a:extLst>
                <a:ext uri="{FF2B5EF4-FFF2-40B4-BE49-F238E27FC236}">
                  <a16:creationId xmlns:a16="http://schemas.microsoft.com/office/drawing/2014/main" id="{FB03B619-DAD0-06A2-DD42-DC0B3E8079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77" y="2352"/>
              <a:ext cx="233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100.0%</a:t>
              </a:r>
              <a:endParaRPr kumimoji="0" lang="hu-HU" altLang="hu-HU" sz="3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7" name="Rectangle 71">
              <a:extLst>
                <a:ext uri="{FF2B5EF4-FFF2-40B4-BE49-F238E27FC236}">
                  <a16:creationId xmlns:a16="http://schemas.microsoft.com/office/drawing/2014/main" id="{734BBBB3-BCCB-91E1-5397-A0ED1DB424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20" y="1971"/>
              <a:ext cx="195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27.8%</a:t>
              </a:r>
              <a:endParaRPr kumimoji="0" lang="hu-HU" altLang="hu-HU" sz="3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8" name="Rectangle 72">
              <a:extLst>
                <a:ext uri="{FF2B5EF4-FFF2-40B4-BE49-F238E27FC236}">
                  <a16:creationId xmlns:a16="http://schemas.microsoft.com/office/drawing/2014/main" id="{7F137C0F-6944-7650-1A30-B8053C41B2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20" y="2067"/>
              <a:ext cx="195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36.1%</a:t>
              </a:r>
              <a:endParaRPr kumimoji="0" lang="hu-HU" altLang="hu-HU" sz="3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9" name="Rectangle 73">
              <a:extLst>
                <a:ext uri="{FF2B5EF4-FFF2-40B4-BE49-F238E27FC236}">
                  <a16:creationId xmlns:a16="http://schemas.microsoft.com/office/drawing/2014/main" id="{CA0F7E26-1BCC-9CE8-3237-6D8E5BD64D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20" y="2163"/>
              <a:ext cx="195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hu-HU" altLang="hu-HU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</a:rPr>
                <a:t>36.1%</a:t>
              </a:r>
              <a:endParaRPr kumimoji="0" lang="hu-HU" altLang="hu-HU" sz="3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1957179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95</Words>
  <Application>Microsoft Office PowerPoint</Application>
  <PresentationFormat>Szélesvásznú</PresentationFormat>
  <Paragraphs>44</Paragraphs>
  <Slides>1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4</vt:i4>
      </vt:variant>
      <vt:variant>
        <vt:lpstr>Téma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-téma</vt:lpstr>
      <vt:lpstr>PowerPoint-bemutat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bemutató</dc:title>
  <dc:creator>Danuta Szirmai</dc:creator>
  <cp:lastModifiedBy>Danuta Szirmai</cp:lastModifiedBy>
  <cp:revision>1</cp:revision>
  <dcterms:created xsi:type="dcterms:W3CDTF">2023-07-20T09:12:30Z</dcterms:created>
  <dcterms:modified xsi:type="dcterms:W3CDTF">2023-07-20T09:23:01Z</dcterms:modified>
</cp:coreProperties>
</file>